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77" y="3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3881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682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3655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266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0750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8327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304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610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180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7592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433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D9BAE-21DD-4456-B58C-811AA961875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A09-D751-4CEB-8F57-C90B869F63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247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34E82AF-DFCE-4DAA-A1DC-CBE7233835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0" t="18960" r="11698" b="14971"/>
          <a:stretch/>
        </p:blipFill>
        <p:spPr>
          <a:xfrm>
            <a:off x="73324" y="1027590"/>
            <a:ext cx="9625349" cy="407924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E0AA6B3-C739-4975-ADF4-1AA817620365}"/>
              </a:ext>
            </a:extLst>
          </p:cNvPr>
          <p:cNvSpPr txBox="1"/>
          <p:nvPr/>
        </p:nvSpPr>
        <p:spPr>
          <a:xfrm>
            <a:off x="3125638" y="5380893"/>
            <a:ext cx="3992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 Figure S2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Oba et al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6AB2B4D-E06F-429F-8A5B-CF078EEE16C4}"/>
              </a:ext>
            </a:extLst>
          </p:cNvPr>
          <p:cNvSpPr txBox="1"/>
          <p:nvPr/>
        </p:nvSpPr>
        <p:spPr>
          <a:xfrm>
            <a:off x="189781" y="1027590"/>
            <a:ext cx="621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51F2E43-43CE-4FB4-88E8-D100B1953819}"/>
              </a:ext>
            </a:extLst>
          </p:cNvPr>
          <p:cNvSpPr txBox="1"/>
          <p:nvPr/>
        </p:nvSpPr>
        <p:spPr>
          <a:xfrm>
            <a:off x="2504536" y="1027590"/>
            <a:ext cx="621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1601FA0-5377-4034-8DBC-DA555BEE4D71}"/>
              </a:ext>
            </a:extLst>
          </p:cNvPr>
          <p:cNvSpPr txBox="1"/>
          <p:nvPr/>
        </p:nvSpPr>
        <p:spPr>
          <a:xfrm>
            <a:off x="4744529" y="1027590"/>
            <a:ext cx="621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FF7F621-7BD2-49A7-A0E0-C4F9F68C2A06}"/>
              </a:ext>
            </a:extLst>
          </p:cNvPr>
          <p:cNvSpPr txBox="1"/>
          <p:nvPr/>
        </p:nvSpPr>
        <p:spPr>
          <a:xfrm>
            <a:off x="7346831" y="1027590"/>
            <a:ext cx="621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CDE5561-1185-F414-6396-D4513DF8D174}"/>
              </a:ext>
            </a:extLst>
          </p:cNvPr>
          <p:cNvSpPr/>
          <p:nvPr/>
        </p:nvSpPr>
        <p:spPr>
          <a:xfrm>
            <a:off x="189164" y="5802554"/>
            <a:ext cx="95276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tructure prediction of the hexon protein of PAdV-5 Ino5, PAdV-5 HNF-61 (AF186621), PAdV-5 HNF-70 (AF289262), porcine adenovirus 3 (AC_000189), and Human adenovirus 3 GB strain (AY599834). The three-dimensional protein structures were predicted by Alphafold2 (https://colab.research.google.com/github/sokrypton/ColabFold/blob/main/AlphaFold2.ipynb) and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sualized using ChimeraX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891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0</TotalTime>
  <Words>95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等线</vt:lpstr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井 誠</dc:creator>
  <cp:lastModifiedBy>MDPI</cp:lastModifiedBy>
  <cp:revision>13</cp:revision>
  <dcterms:created xsi:type="dcterms:W3CDTF">2022-09-08T08:29:11Z</dcterms:created>
  <dcterms:modified xsi:type="dcterms:W3CDTF">2022-10-29T11:01:04Z</dcterms:modified>
</cp:coreProperties>
</file>